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8999538"/>
  <p:notesSz cx="6735763" cy="9866313"/>
  <p:defaultTextStyle>
    <a:defPPr>
      <a:defRPr lang="ja-JP"/>
    </a:defPPr>
    <a:lvl1pPr marL="0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1pPr>
    <a:lvl2pPr marL="657179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2pPr>
    <a:lvl3pPr marL="1314359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3pPr>
    <a:lvl4pPr marL="1971538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4pPr>
    <a:lvl5pPr marL="2628717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5pPr>
    <a:lvl6pPr marL="3285896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6pPr>
    <a:lvl7pPr marL="3943076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7pPr>
    <a:lvl8pPr marL="4600255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8pPr>
    <a:lvl9pPr marL="5257434" algn="l" defTabSz="1314359" rtl="0" eaLnBrk="1" latinLnBrk="0" hangingPunct="1">
      <a:defRPr kumimoji="1" sz="258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245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山下 継史" userId="53c0dca2e6514f2b" providerId="LiveId" clId="{B9C6CECA-AD71-42F9-B63C-2854E50D0F3C}"/>
    <pc:docChg chg="custSel modSld">
      <pc:chgData name="山下 継史" userId="53c0dca2e6514f2b" providerId="LiveId" clId="{B9C6CECA-AD71-42F9-B63C-2854E50D0F3C}" dt="2023-04-25T02:35:30.199" v="17" actId="1076"/>
      <pc:docMkLst>
        <pc:docMk/>
      </pc:docMkLst>
      <pc:sldChg chg="addSp delSp modSp mod">
        <pc:chgData name="山下 継史" userId="53c0dca2e6514f2b" providerId="LiveId" clId="{B9C6CECA-AD71-42F9-B63C-2854E50D0F3C}" dt="2023-04-25T02:35:30.199" v="17" actId="1076"/>
        <pc:sldMkLst>
          <pc:docMk/>
          <pc:sldMk cId="1278737035" sldId="256"/>
        </pc:sldMkLst>
        <pc:spChg chg="add mod">
          <ac:chgData name="山下 継史" userId="53c0dca2e6514f2b" providerId="LiveId" clId="{B9C6CECA-AD71-42F9-B63C-2854E50D0F3C}" dt="2023-04-25T02:35:17.372" v="15" actId="20577"/>
          <ac:spMkLst>
            <pc:docMk/>
            <pc:sldMk cId="1278737035" sldId="256"/>
            <ac:spMk id="2" creationId="{87FD0DB4-93FA-65E8-F7F0-578969DFADDF}"/>
          </ac:spMkLst>
        </pc:spChg>
        <pc:spChg chg="del">
          <ac:chgData name="山下 継史" userId="53c0dca2e6514f2b" providerId="LiveId" clId="{B9C6CECA-AD71-42F9-B63C-2854E50D0F3C}" dt="2023-04-25T02:35:22.680" v="16" actId="478"/>
          <ac:spMkLst>
            <pc:docMk/>
            <pc:sldMk cId="1278737035" sldId="256"/>
            <ac:spMk id="25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31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32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33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36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37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38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41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42" creationId="{00000000-0000-0000-0000-000000000000}"/>
          </ac:spMkLst>
        </pc:spChg>
        <pc:spChg chg="mod">
          <ac:chgData name="山下 継史" userId="53c0dca2e6514f2b" providerId="LiveId" clId="{B9C6CECA-AD71-42F9-B63C-2854E50D0F3C}" dt="2023-04-25T02:35:04.239" v="5" actId="113"/>
          <ac:spMkLst>
            <pc:docMk/>
            <pc:sldMk cId="1278737035" sldId="256"/>
            <ac:spMk id="43" creationId="{00000000-0000-0000-0000-000000000000}"/>
          </ac:spMkLst>
        </pc:spChg>
        <pc:grpChg chg="mod">
          <ac:chgData name="山下 継史" userId="53c0dca2e6514f2b" providerId="LiveId" clId="{B9C6CECA-AD71-42F9-B63C-2854E50D0F3C}" dt="2023-04-25T02:35:30.199" v="17" actId="1076"/>
          <ac:grpSpMkLst>
            <pc:docMk/>
            <pc:sldMk cId="1278737035" sldId="256"/>
            <ac:grpSpMk id="26" creationId="{00000000-0000-0000-0000-000000000000}"/>
          </ac:grpSpMkLst>
        </pc:grpChg>
        <pc:grpChg chg="mod">
          <ac:chgData name="山下 継史" userId="53c0dca2e6514f2b" providerId="LiveId" clId="{B9C6CECA-AD71-42F9-B63C-2854E50D0F3C}" dt="2023-04-25T02:35:30.199" v="17" actId="1076"/>
          <ac:grpSpMkLst>
            <pc:docMk/>
            <pc:sldMk cId="1278737035" sldId="256"/>
            <ac:grpSpMk id="34" creationId="{00000000-0000-0000-0000-000000000000}"/>
          </ac:grpSpMkLst>
        </pc:grpChg>
        <pc:grpChg chg="mod">
          <ac:chgData name="山下 継史" userId="53c0dca2e6514f2b" providerId="LiveId" clId="{B9C6CECA-AD71-42F9-B63C-2854E50D0F3C}" dt="2023-04-25T02:35:30.199" v="17" actId="1076"/>
          <ac:grpSpMkLst>
            <pc:docMk/>
            <pc:sldMk cId="1278737035" sldId="256"/>
            <ac:grpSpMk id="39" creationId="{00000000-0000-0000-0000-000000000000}"/>
          </ac:grpSpMkLst>
        </pc:gr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4497"/>
          </a:xfrm>
          <a:prstGeom prst="rect">
            <a:avLst/>
          </a:prstGeom>
        </p:spPr>
        <p:txBody>
          <a:bodyPr vert="horz" lIns="90343" tIns="45171" rIns="90343" bIns="4517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4497"/>
          </a:xfrm>
          <a:prstGeom prst="rect">
            <a:avLst/>
          </a:prstGeom>
        </p:spPr>
        <p:txBody>
          <a:bodyPr vert="horz" lIns="90343" tIns="45171" rIns="90343" bIns="45171" rtlCol="0"/>
          <a:lstStyle>
            <a:lvl1pPr algn="r">
              <a:defRPr sz="1200"/>
            </a:lvl1pPr>
          </a:lstStyle>
          <a:p>
            <a:fld id="{4EA22E7B-0514-4847-A50B-033C381AC60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817"/>
            <a:ext cx="2918831" cy="494497"/>
          </a:xfrm>
          <a:prstGeom prst="rect">
            <a:avLst/>
          </a:prstGeom>
        </p:spPr>
        <p:txBody>
          <a:bodyPr vert="horz" lIns="90343" tIns="45171" rIns="90343" bIns="4517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817"/>
            <a:ext cx="2918831" cy="494497"/>
          </a:xfrm>
          <a:prstGeom prst="rect">
            <a:avLst/>
          </a:prstGeom>
        </p:spPr>
        <p:txBody>
          <a:bodyPr vert="horz" lIns="90343" tIns="45171" rIns="90343" bIns="45171" rtlCol="0" anchor="b"/>
          <a:lstStyle>
            <a:lvl1pPr algn="r">
              <a:defRPr sz="1200"/>
            </a:lvl1pPr>
          </a:lstStyle>
          <a:p>
            <a:fld id="{AC859996-20B5-4704-9B54-2F3E0DB14C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8033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0343" tIns="45171" rIns="90343" bIns="4517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0343" tIns="45171" rIns="90343" bIns="45171" rtlCol="0"/>
          <a:lstStyle>
            <a:lvl1pPr algn="r">
              <a:defRPr sz="1200"/>
            </a:lvl1pPr>
          </a:lstStyle>
          <a:p>
            <a:fld id="{8AF41537-05A9-464F-BE7A-90FA467E3DD3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0263" y="1233488"/>
            <a:ext cx="2535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343" tIns="45171" rIns="90343" bIns="4517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0343" tIns="45171" rIns="90343" bIns="4517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0343" tIns="45171" rIns="90343" bIns="4517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0343" tIns="45171" rIns="90343" bIns="45171" rtlCol="0" anchor="b"/>
          <a:lstStyle>
            <a:lvl1pPr algn="r">
              <a:defRPr sz="1200"/>
            </a:lvl1pPr>
          </a:lstStyle>
          <a:p>
            <a:fld id="{89ED07CE-314F-4753-A42A-2E5E766CD1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0339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1pPr>
    <a:lvl2pPr marL="657179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2pPr>
    <a:lvl3pPr marL="1314359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3pPr>
    <a:lvl4pPr marL="1971538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4pPr>
    <a:lvl5pPr marL="2628717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5pPr>
    <a:lvl6pPr marL="3285896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6pPr>
    <a:lvl7pPr marL="3943076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7pPr>
    <a:lvl8pPr marL="4600255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8pPr>
    <a:lvl9pPr marL="5257434" algn="l" defTabSz="1314359" rtl="0" eaLnBrk="1" latinLnBrk="0" hangingPunct="1">
      <a:defRPr kumimoji="1" sz="172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00263" y="1233488"/>
            <a:ext cx="2535237" cy="33305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ED07CE-314F-4753-A42A-2E5E766CD1E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06370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2842"/>
            <a:ext cx="5829300" cy="313317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26842"/>
            <a:ext cx="5143500" cy="217280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7320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836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142"/>
            <a:ext cx="1478756" cy="762669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142"/>
            <a:ext cx="4350544" cy="762669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189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664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3638"/>
            <a:ext cx="5915025" cy="374355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22610"/>
            <a:ext cx="5915025" cy="19686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391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5710"/>
            <a:ext cx="2914650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5710"/>
            <a:ext cx="2914650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961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144"/>
            <a:ext cx="5915025" cy="1739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6137"/>
            <a:ext cx="2901255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87331"/>
            <a:ext cx="2901255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6137"/>
            <a:ext cx="2915543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87331"/>
            <a:ext cx="2915543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9678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8304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95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5769"/>
            <a:ext cx="3471863" cy="639550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449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5769"/>
            <a:ext cx="3471863" cy="639550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816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144"/>
            <a:ext cx="5915025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5710"/>
            <a:ext cx="5915025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FD099B-DF18-4E95-B9E9-1EFA1F77EE7F}" type="datetimeFigureOut">
              <a:rPr kumimoji="1" lang="ja-JP" altLang="en-US" smtClean="0"/>
              <a:t>2023/4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41240"/>
            <a:ext cx="231457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153E8-5B26-4CB0-8334-A8D34EF5B4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358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="" xmlns:a16="http://schemas.microsoft.com/office/drawing/2014/main" id="{87FD0DB4-93FA-65E8-F7F0-578969DFADDF}"/>
              </a:ext>
            </a:extLst>
          </p:cNvPr>
          <p:cNvSpPr txBox="1"/>
          <p:nvPr/>
        </p:nvSpPr>
        <p:spPr>
          <a:xfrm>
            <a:off x="307460" y="368135"/>
            <a:ext cx="9396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320890" y="2311774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 smtClean="0">
                <a:cs typeface="Times New Roman" panose="02020603050405020304" pitchFamily="18" charset="0"/>
              </a:rPr>
              <a:t>P=0.44</a:t>
            </a:r>
          </a:p>
        </p:txBody>
      </p:sp>
      <p:grpSp>
        <p:nvGrpSpPr>
          <p:cNvPr id="8" name="グループ化 7"/>
          <p:cNvGrpSpPr/>
          <p:nvPr/>
        </p:nvGrpSpPr>
        <p:grpSpPr>
          <a:xfrm>
            <a:off x="3579830" y="1386072"/>
            <a:ext cx="3044540" cy="3111465"/>
            <a:chOff x="3579830" y="1386072"/>
            <a:chExt cx="3044540" cy="3111465"/>
          </a:xfrm>
        </p:grpSpPr>
        <p:grpSp>
          <p:nvGrpSpPr>
            <p:cNvPr id="6" name="グループ化 5"/>
            <p:cNvGrpSpPr/>
            <p:nvPr/>
          </p:nvGrpSpPr>
          <p:grpSpPr>
            <a:xfrm>
              <a:off x="3579830" y="1386072"/>
              <a:ext cx="3044540" cy="3111465"/>
              <a:chOff x="3579830" y="1386072"/>
              <a:chExt cx="3044540" cy="3111465"/>
            </a:xfrm>
          </p:grpSpPr>
          <p:graphicFrame>
            <p:nvGraphicFramePr>
              <p:cNvPr id="29" name="オブジェクト 2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83897943"/>
                  </p:ext>
                </p:extLst>
              </p:nvPr>
            </p:nvGraphicFramePr>
            <p:xfrm>
              <a:off x="3579830" y="1437537"/>
              <a:ext cx="3044540" cy="3060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4" name="SPW 14.0 Graph" r:id="rId4" imgW="5653969" imgH="5509166" progId="SigmaPlotGraphicObject.13">
                      <p:embed/>
                    </p:oleObj>
                  </mc:Choice>
                  <mc:Fallback>
                    <p:oleObj name="SPW 14.0 Graph" r:id="rId4" imgW="5653969" imgH="5509166" progId="SigmaPlotGraphicObject.13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579830" y="1437537"/>
                            <a:ext cx="3044540" cy="3060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0" name="テキスト ボックス 29"/>
              <p:cNvSpPr txBox="1"/>
              <p:nvPr/>
            </p:nvSpPr>
            <p:spPr>
              <a:xfrm>
                <a:off x="3842203" y="1386072"/>
                <a:ext cx="267413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2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) Gait speed over 10m</a:t>
                </a:r>
                <a:endParaRPr kumimoji="1" lang="ja-JP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テキスト ボックス 43"/>
              <p:cNvSpPr txBox="1"/>
              <p:nvPr/>
            </p:nvSpPr>
            <p:spPr>
              <a:xfrm>
                <a:off x="4194034" y="2389443"/>
                <a:ext cx="83548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800" b="1" dirty="0" smtClean="0">
                    <a:cs typeface="Times New Roman" panose="02020603050405020304" pitchFamily="18" charset="0"/>
                  </a:rPr>
                  <a:t>P=0.09</a:t>
                </a:r>
              </a:p>
            </p:txBody>
          </p:sp>
          <p:sp>
            <p:nvSpPr>
              <p:cNvPr id="46" name="テキスト ボックス 45"/>
              <p:cNvSpPr txBox="1"/>
              <p:nvPr/>
            </p:nvSpPr>
            <p:spPr>
              <a:xfrm>
                <a:off x="5611694" y="2808404"/>
                <a:ext cx="82747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800" dirty="0" smtClean="0">
                    <a:cs typeface="Times New Roman" panose="02020603050405020304" pitchFamily="18" charset="0"/>
                  </a:rPr>
                  <a:t>P=0.14</a:t>
                </a:r>
              </a:p>
            </p:txBody>
          </p:sp>
          <p:sp>
            <p:nvSpPr>
              <p:cNvPr id="47" name="テキスト ボックス 46"/>
              <p:cNvSpPr txBox="1"/>
              <p:nvPr/>
            </p:nvSpPr>
            <p:spPr>
              <a:xfrm>
                <a:off x="4853837" y="1987525"/>
                <a:ext cx="82747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800" dirty="0" smtClean="0">
                    <a:cs typeface="Times New Roman" panose="02020603050405020304" pitchFamily="18" charset="0"/>
                  </a:rPr>
                  <a:t>P=0.14</a:t>
                </a:r>
              </a:p>
            </p:txBody>
          </p:sp>
        </p:grpSp>
        <p:sp>
          <p:nvSpPr>
            <p:cNvPr id="55" name="テキスト ボックス 54"/>
            <p:cNvSpPr txBox="1"/>
            <p:nvPr/>
          </p:nvSpPr>
          <p:spPr>
            <a:xfrm>
              <a:off x="4340708" y="3681535"/>
              <a:ext cx="542136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D7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5102100" y="3680944"/>
              <a:ext cx="383438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M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5704794" y="3709364"/>
              <a:ext cx="383438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M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グループ化 6"/>
          <p:cNvGrpSpPr/>
          <p:nvPr/>
        </p:nvGrpSpPr>
        <p:grpSpPr>
          <a:xfrm>
            <a:off x="227093" y="1378033"/>
            <a:ext cx="3132000" cy="3153347"/>
            <a:chOff x="227093" y="1378033"/>
            <a:chExt cx="3132000" cy="3153347"/>
          </a:xfrm>
        </p:grpSpPr>
        <p:grpSp>
          <p:nvGrpSpPr>
            <p:cNvPr id="5" name="グループ化 4"/>
            <p:cNvGrpSpPr/>
            <p:nvPr/>
          </p:nvGrpSpPr>
          <p:grpSpPr>
            <a:xfrm>
              <a:off x="227093" y="1378033"/>
              <a:ext cx="3132000" cy="3153347"/>
              <a:chOff x="227093" y="1378033"/>
              <a:chExt cx="3132000" cy="3153347"/>
            </a:xfrm>
          </p:grpSpPr>
          <p:graphicFrame>
            <p:nvGraphicFramePr>
              <p:cNvPr id="18" name="オブジェクト 1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870144321"/>
                  </p:ext>
                </p:extLst>
              </p:nvPr>
            </p:nvGraphicFramePr>
            <p:xfrm>
              <a:off x="227093" y="1645908"/>
              <a:ext cx="3132000" cy="288547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5" name="SPW 14.0 Graph" r:id="rId6" imgW="5494055" imgH="5181679" progId="SigmaPlotGraphicObject.13">
                      <p:embed/>
                    </p:oleObj>
                  </mc:Choice>
                  <mc:Fallback>
                    <p:oleObj name="SPW 14.0 Graph" r:id="rId6" imgW="5494055" imgH="5181679" progId="SigmaPlotGraphicObject.13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227093" y="1645908"/>
                            <a:ext cx="3132000" cy="288547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" name="テキスト ボックス 2"/>
              <p:cNvSpPr txBox="1"/>
              <p:nvPr/>
            </p:nvSpPr>
            <p:spPr>
              <a:xfrm>
                <a:off x="360978" y="1378033"/>
                <a:ext cx="245291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2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) Hand grip strength</a:t>
                </a:r>
                <a:endParaRPr kumimoji="1" lang="ja-JP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テキスト ボックス 3"/>
              <p:cNvSpPr txBox="1"/>
              <p:nvPr/>
            </p:nvSpPr>
            <p:spPr>
              <a:xfrm>
                <a:off x="777300" y="2387369"/>
                <a:ext cx="86113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800" b="1" dirty="0" smtClean="0">
                    <a:cs typeface="Times New Roman" panose="02020603050405020304" pitchFamily="18" charset="0"/>
                  </a:rPr>
                  <a:t>P=0.08</a:t>
                </a:r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>
                <a:off x="1638433" y="2967537"/>
                <a:ext cx="83548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800" dirty="0" smtClean="0">
                    <a:cs typeface="Times New Roman" panose="02020603050405020304" pitchFamily="18" charset="0"/>
                  </a:rPr>
                  <a:t>P=0.22</a:t>
                </a:r>
              </a:p>
            </p:txBody>
          </p:sp>
        </p:grpSp>
        <p:sp>
          <p:nvSpPr>
            <p:cNvPr id="53" name="テキスト ボックス 52"/>
            <p:cNvSpPr txBox="1"/>
            <p:nvPr/>
          </p:nvSpPr>
          <p:spPr>
            <a:xfrm>
              <a:off x="976073" y="3736492"/>
              <a:ext cx="542136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D7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1679119" y="3736492"/>
              <a:ext cx="383438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M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2389832" y="3736491"/>
              <a:ext cx="383438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M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グループ化 8"/>
          <p:cNvGrpSpPr/>
          <p:nvPr/>
        </p:nvGrpSpPr>
        <p:grpSpPr>
          <a:xfrm>
            <a:off x="1346548" y="4981381"/>
            <a:ext cx="4682116" cy="3128128"/>
            <a:chOff x="1176211" y="5158950"/>
            <a:chExt cx="4682116" cy="3128128"/>
          </a:xfrm>
        </p:grpSpPr>
        <p:graphicFrame>
          <p:nvGraphicFramePr>
            <p:cNvPr id="48" name="オブジェクト 4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80320274"/>
                </p:ext>
              </p:extLst>
            </p:nvPr>
          </p:nvGraphicFramePr>
          <p:xfrm>
            <a:off x="1774726" y="5227078"/>
            <a:ext cx="3079111" cy="30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6" name="SPW 14.0 Graph" r:id="rId8" imgW="5547218" imgH="5509166" progId="SigmaPlotGraphicObject.13">
                    <p:embed/>
                  </p:oleObj>
                </mc:Choice>
                <mc:Fallback>
                  <p:oleObj name="SPW 14.0 Graph" r:id="rId8" imgW="5547218" imgH="5509166" progId="SigmaPlotGraphicObject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774726" y="5227078"/>
                          <a:ext cx="3079111" cy="30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9" name="テキスト ボックス 48"/>
            <p:cNvSpPr txBox="1"/>
            <p:nvPr/>
          </p:nvSpPr>
          <p:spPr>
            <a:xfrm>
              <a:off x="1176211" y="5158950"/>
              <a:ext cx="468211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</a:t>
              </a:r>
              <a:r>
                <a:rPr kumimoji="1" lang="en-US" altLang="ja-JP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ve-repetition </a:t>
              </a:r>
              <a:r>
                <a:rPr lang="en-US" altLang="ja-JP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t-to-stand test (SS-5; s)</a:t>
              </a:r>
              <a:r>
                <a:rPr kumimoji="1" lang="en-US" altLang="ja-JP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1"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3058974" y="5676754"/>
              <a:ext cx="8354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800" b="1" dirty="0" smtClean="0">
                  <a:cs typeface="Times New Roman" panose="02020603050405020304" pitchFamily="18" charset="0"/>
                </a:rPr>
                <a:t>P=0.06</a:t>
              </a: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2400158" y="6992254"/>
              <a:ext cx="8274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800" dirty="0" smtClean="0">
                  <a:cs typeface="Times New Roman" panose="02020603050405020304" pitchFamily="18" charset="0"/>
                </a:rPr>
                <a:t>P=0.10</a:t>
              </a: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3731192" y="6149838"/>
              <a:ext cx="8274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800" dirty="0" smtClean="0">
                  <a:cs typeface="Times New Roman" panose="02020603050405020304" pitchFamily="18" charset="0"/>
                </a:rPr>
                <a:t>P=0.47</a:t>
              </a: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2542825" y="7499986"/>
              <a:ext cx="542136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D7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3227629" y="7498511"/>
              <a:ext cx="383438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M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3894459" y="7512584"/>
              <a:ext cx="383438" cy="256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67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M</a:t>
              </a:r>
              <a:endParaRPr lang="ja-JP" altLang="en-US" sz="1067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78737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</TotalTime>
  <Words>46</Words>
  <Application>Microsoft Office PowerPoint</Application>
  <PresentationFormat>ユーザー設定</PresentationFormat>
  <Paragraphs>23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SPW 14.0 Graph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櫻谷美貴子</dc:creator>
  <cp:lastModifiedBy>櫻谷美貴子</cp:lastModifiedBy>
  <cp:revision>38</cp:revision>
  <cp:lastPrinted>2022-12-02T11:16:52Z</cp:lastPrinted>
  <dcterms:created xsi:type="dcterms:W3CDTF">2022-01-23T19:55:16Z</dcterms:created>
  <dcterms:modified xsi:type="dcterms:W3CDTF">2023-04-30T11:07:02Z</dcterms:modified>
</cp:coreProperties>
</file>